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A1D00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44" autoAdjust="0"/>
    <p:restoredTop sz="94707" autoAdjust="0"/>
  </p:normalViewPr>
  <p:slideViewPr>
    <p:cSldViewPr snapToGrid="0">
      <p:cViewPr varScale="1">
        <p:scale>
          <a:sx n="74" d="100"/>
          <a:sy n="74" d="100"/>
        </p:scale>
        <p:origin x="3558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16A42D-D3E0-461C-AEE7-9F4F0E61BE54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2E81D3-2BC8-4FF6-80AE-DC4D9087B4F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80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164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428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1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87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67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88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399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891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3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816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59829-B15C-4393-99F8-F1D7FB5B5D9F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385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169006" y="260119"/>
            <a:ext cx="6489538" cy="2995433"/>
            <a:chOff x="169006" y="260119"/>
            <a:chExt cx="6489538" cy="2995433"/>
          </a:xfrm>
        </p:grpSpPr>
        <p:sp>
          <p:nvSpPr>
            <p:cNvPr id="20" name="Textfeld 19"/>
            <p:cNvSpPr txBox="1"/>
            <p:nvPr/>
          </p:nvSpPr>
          <p:spPr>
            <a:xfrm>
              <a:off x="205937" y="2239889"/>
              <a:ext cx="644612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1200"/>
                </a:lnSpc>
              </a:pP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Material S1: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chronic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cortical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cerebral microinfarct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in the superior frontal gyrus with minor tissu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thinning that is located in mid-cortical layers (case 6)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is shown in two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neighboring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100µm-thick brain sections stained with the pigment Nissl (PN)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and modified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H&amp;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ains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b-c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.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thick brain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ections, th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boundaries of th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pale microinfarct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re clearly evident in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PN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ain, but the paleness of th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microinfarction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zone is more difficult to discern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n the modified H&amp;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ain. Th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nset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shows an enlaged area from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with various cell types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nd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vessels (arrow)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n th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core of th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microinfarct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ained with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H&amp;E.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Scale bars: 4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00 µm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a-b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nd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µm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  <a:endParaRPr lang="en-US" sz="8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69006" y="260119"/>
              <a:ext cx="26581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1</a:t>
              </a:r>
              <a:endParaRPr 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uppieren 4"/>
            <p:cNvGrpSpPr/>
            <p:nvPr/>
          </p:nvGrpSpPr>
          <p:grpSpPr>
            <a:xfrm>
              <a:off x="189986" y="648970"/>
              <a:ext cx="6468558" cy="1552812"/>
              <a:chOff x="189986" y="648970"/>
              <a:chExt cx="6468558" cy="1552812"/>
            </a:xfrm>
          </p:grpSpPr>
          <p:pic>
            <p:nvPicPr>
              <p:cNvPr id="40" name="Grafik 39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266723" y="716982"/>
                <a:ext cx="2088000" cy="1484800"/>
              </a:xfrm>
              <a:prstGeom prst="rect">
                <a:avLst/>
              </a:prstGeom>
            </p:spPr>
          </p:pic>
          <p:pic>
            <p:nvPicPr>
              <p:cNvPr id="50" name="Grafik 4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2387714" y="716982"/>
                <a:ext cx="2088000" cy="1484800"/>
              </a:xfrm>
              <a:prstGeom prst="rect">
                <a:avLst/>
              </a:prstGeom>
            </p:spPr>
          </p:pic>
          <p:pic>
            <p:nvPicPr>
              <p:cNvPr id="38" name="Grafik 3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08705" y="716982"/>
                <a:ext cx="2088000" cy="1484800"/>
              </a:xfrm>
              <a:prstGeom prst="rect">
                <a:avLst/>
              </a:prstGeom>
            </p:spPr>
          </p:pic>
          <p:sp>
            <p:nvSpPr>
              <p:cNvPr id="12" name="Rechteck 11"/>
              <p:cNvSpPr>
                <a:spLocks noChangeAspect="1"/>
              </p:cNvSpPr>
              <p:nvPr/>
            </p:nvSpPr>
            <p:spPr>
              <a:xfrm>
                <a:off x="2910788" y="1048530"/>
                <a:ext cx="835200" cy="59328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3678994" y="868013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1959715" y="694096"/>
                <a:ext cx="4347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N</a:t>
                </a:r>
                <a:endParaRPr 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3976841" y="694096"/>
                <a:ext cx="56457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&amp;E</a:t>
                </a:r>
                <a:endParaRPr 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" name="Gerade Verbindung mit Pfeil 21"/>
              <p:cNvCxnSpPr>
                <a:cxnSpLocks noChangeAspect="1"/>
              </p:cNvCxnSpPr>
              <p:nvPr/>
            </p:nvCxnSpPr>
            <p:spPr>
              <a:xfrm flipH="1">
                <a:off x="5652908" y="1081061"/>
                <a:ext cx="144000" cy="49847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r Verbinder 27"/>
              <p:cNvCxnSpPr/>
              <p:nvPr/>
            </p:nvCxnSpPr>
            <p:spPr>
              <a:xfrm flipV="1">
                <a:off x="1850963" y="2110421"/>
                <a:ext cx="4356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r Verbinder 28"/>
              <p:cNvCxnSpPr/>
              <p:nvPr/>
            </p:nvCxnSpPr>
            <p:spPr>
              <a:xfrm flipV="1">
                <a:off x="3963707" y="2110421"/>
                <a:ext cx="4356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Gerader Verbinder 29"/>
              <p:cNvCxnSpPr/>
              <p:nvPr/>
            </p:nvCxnSpPr>
            <p:spPr>
              <a:xfrm flipV="1">
                <a:off x="6051738" y="2110421"/>
                <a:ext cx="4716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feld 38"/>
              <p:cNvSpPr txBox="1"/>
              <p:nvPr/>
            </p:nvSpPr>
            <p:spPr>
              <a:xfrm>
                <a:off x="6093966" y="694096"/>
                <a:ext cx="56457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&amp;E</a:t>
                </a:r>
                <a:endParaRPr lang="en-US" sz="1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" name="Gruppieren 1"/>
              <p:cNvGrpSpPr>
                <a:grpSpLocks noChangeAspect="1"/>
              </p:cNvGrpSpPr>
              <p:nvPr/>
            </p:nvGrpSpPr>
            <p:grpSpPr>
              <a:xfrm>
                <a:off x="288414" y="877929"/>
                <a:ext cx="1318245" cy="1137895"/>
                <a:chOff x="4681551" y="731056"/>
                <a:chExt cx="1292397" cy="1256923"/>
              </a:xfrm>
            </p:grpSpPr>
            <p:sp>
              <p:nvSpPr>
                <p:cNvPr id="19" name="Gleichschenkliges Dreieck 18"/>
                <p:cNvSpPr>
                  <a:spLocks noChangeAspect="1"/>
                </p:cNvSpPr>
                <p:nvPr/>
              </p:nvSpPr>
              <p:spPr>
                <a:xfrm>
                  <a:off x="5067617" y="1906857"/>
                  <a:ext cx="51667" cy="81122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Gleichschenkliges Dreieck 20"/>
                <p:cNvSpPr>
                  <a:spLocks noChangeAspect="1"/>
                </p:cNvSpPr>
                <p:nvPr/>
              </p:nvSpPr>
              <p:spPr>
                <a:xfrm rot="15957909">
                  <a:off x="5893422" y="1067324"/>
                  <a:ext cx="72000" cy="89053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Gleichschenkliges Dreieck 22"/>
                <p:cNvSpPr>
                  <a:spLocks noChangeAspect="1"/>
                </p:cNvSpPr>
                <p:nvPr/>
              </p:nvSpPr>
              <p:spPr>
                <a:xfrm rot="18720000">
                  <a:off x="5343771" y="1401814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" name="Gleichschenkliges Dreieck 23"/>
                <p:cNvSpPr>
                  <a:spLocks noChangeAspect="1"/>
                </p:cNvSpPr>
                <p:nvPr/>
              </p:nvSpPr>
              <p:spPr>
                <a:xfrm rot="5642091" flipH="1">
                  <a:off x="4688444" y="1258415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Gleichschenkliges Dreieck 24"/>
                <p:cNvSpPr>
                  <a:spLocks noChangeAspect="1"/>
                </p:cNvSpPr>
                <p:nvPr/>
              </p:nvSpPr>
              <p:spPr>
                <a:xfrm rot="7263368" flipH="1">
                  <a:off x="4892709" y="828148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Gleichschenkliges Dreieck 25"/>
                <p:cNvSpPr>
                  <a:spLocks noChangeAspect="1"/>
                </p:cNvSpPr>
                <p:nvPr/>
              </p:nvSpPr>
              <p:spPr>
                <a:xfrm rot="12960000">
                  <a:off x="5482728" y="731056"/>
                  <a:ext cx="51667" cy="81122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9" name="Textfeld 8"/>
              <p:cNvSpPr txBox="1"/>
              <p:nvPr/>
            </p:nvSpPr>
            <p:spPr>
              <a:xfrm>
                <a:off x="189986" y="648970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2310216" y="648970"/>
                <a:ext cx="3097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4433121" y="648970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8" name="Gruppieren 57"/>
              <p:cNvGrpSpPr>
                <a:grpSpLocks noChangeAspect="1"/>
              </p:cNvGrpSpPr>
              <p:nvPr/>
            </p:nvGrpSpPr>
            <p:grpSpPr>
              <a:xfrm>
                <a:off x="2620743" y="898655"/>
                <a:ext cx="1273119" cy="1065370"/>
                <a:chOff x="4681551" y="731056"/>
                <a:chExt cx="1315065" cy="1239897"/>
              </a:xfrm>
            </p:grpSpPr>
            <p:sp>
              <p:nvSpPr>
                <p:cNvPr id="59" name="Gleichschenkliges Dreieck 58"/>
                <p:cNvSpPr>
                  <a:spLocks noChangeAspect="1"/>
                </p:cNvSpPr>
                <p:nvPr/>
              </p:nvSpPr>
              <p:spPr>
                <a:xfrm>
                  <a:off x="5112953" y="1889831"/>
                  <a:ext cx="51667" cy="81122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" name="Gleichschenkliges Dreieck 59"/>
                <p:cNvSpPr>
                  <a:spLocks noChangeAspect="1"/>
                </p:cNvSpPr>
                <p:nvPr/>
              </p:nvSpPr>
              <p:spPr>
                <a:xfrm rot="15957909">
                  <a:off x="5916090" y="1067324"/>
                  <a:ext cx="72000" cy="89053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" name="Gleichschenkliges Dreieck 60"/>
                <p:cNvSpPr>
                  <a:spLocks noChangeAspect="1"/>
                </p:cNvSpPr>
                <p:nvPr/>
              </p:nvSpPr>
              <p:spPr>
                <a:xfrm rot="18720000">
                  <a:off x="5343771" y="1401814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" name="Gleichschenkliges Dreieck 61"/>
                <p:cNvSpPr>
                  <a:spLocks noChangeAspect="1"/>
                </p:cNvSpPr>
                <p:nvPr/>
              </p:nvSpPr>
              <p:spPr>
                <a:xfrm rot="5642091" flipH="1">
                  <a:off x="4688444" y="1258415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" name="Gleichschenkliges Dreieck 62"/>
                <p:cNvSpPr>
                  <a:spLocks noChangeAspect="1"/>
                </p:cNvSpPr>
                <p:nvPr/>
              </p:nvSpPr>
              <p:spPr>
                <a:xfrm rot="7263368" flipH="1">
                  <a:off x="4892709" y="828148"/>
                  <a:ext cx="58213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" name="Gleichschenkliges Dreieck 63"/>
                <p:cNvSpPr>
                  <a:spLocks noChangeAspect="1"/>
                </p:cNvSpPr>
                <p:nvPr/>
              </p:nvSpPr>
              <p:spPr>
                <a:xfrm rot="12960000">
                  <a:off x="5482728" y="731056"/>
                  <a:ext cx="51667" cy="81122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68155964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7</Words>
  <Application>Microsoft Office PowerPoint</Application>
  <PresentationFormat>A4-Papi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Larissa</vt:lpstr>
      <vt:lpstr>PowerPoint-Präsentation</vt:lpstr>
    </vt:vector>
  </TitlesOfParts>
  <Company>Universitätsklinikum Ul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ilmazer Hanke</dc:creator>
  <cp:lastModifiedBy>Yilmazer Hanke</cp:lastModifiedBy>
  <cp:revision>300</cp:revision>
  <dcterms:created xsi:type="dcterms:W3CDTF">2019-05-14T10:42:36Z</dcterms:created>
  <dcterms:modified xsi:type="dcterms:W3CDTF">2020-02-11T13:46:39Z</dcterms:modified>
</cp:coreProperties>
</file>